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3" r:id="rId2"/>
  </p:sldIdLst>
  <p:sldSz cx="6859588" cy="9145588"/>
  <p:notesSz cx="7104063" cy="102346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1513" autoAdjust="0"/>
  </p:normalViewPr>
  <p:slideViewPr>
    <p:cSldViewPr>
      <p:cViewPr>
        <p:scale>
          <a:sx n="100" d="100"/>
          <a:sy n="100" d="100"/>
        </p:scale>
        <p:origin x="-1224" y="2520"/>
      </p:cViewPr>
      <p:guideLst>
        <p:guide orient="horz" pos="2881"/>
        <p:guide pos="216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1" y="3"/>
            <a:ext cx="3078427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3993" y="3"/>
            <a:ext cx="3078427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48FB555D-CF7C-4718-93A9-26D00069D013}" type="datetimeFigureOut">
              <a:rPr lang="zh-CN" altLang="en-US" smtClean="0"/>
              <a:t>2017/10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12963" y="768350"/>
            <a:ext cx="2878137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10407" y="4861441"/>
            <a:ext cx="5683250" cy="4605576"/>
          </a:xfrm>
          <a:prstGeom prst="rect">
            <a:avLst/>
          </a:prstGeom>
        </p:spPr>
        <p:txBody>
          <a:bodyPr vert="horz" lIns="99048" tIns="49524" rIns="99048" bIns="49524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1" y="9721109"/>
            <a:ext cx="3078427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3993" y="9721109"/>
            <a:ext cx="3078427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B8D76316-44A7-46D1-BCC6-F85B673A9F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61623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469" y="2841061"/>
            <a:ext cx="5830650" cy="1960374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938" y="5182500"/>
            <a:ext cx="4801712" cy="233720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3201" y="366248"/>
            <a:ext cx="1543407" cy="780338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80" y="366248"/>
            <a:ext cx="4515895" cy="780338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860" y="5876888"/>
            <a:ext cx="5830650" cy="181641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860" y="3876291"/>
            <a:ext cx="5830650" cy="200059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80" y="2133971"/>
            <a:ext cx="3029651" cy="603566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957" y="2133971"/>
            <a:ext cx="3029651" cy="603566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79" y="2047173"/>
            <a:ext cx="3030843" cy="85316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79" y="2900337"/>
            <a:ext cx="3030843" cy="526929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4576" y="2047173"/>
            <a:ext cx="3032033" cy="85316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4576" y="2900337"/>
            <a:ext cx="3032033" cy="526929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80" y="364130"/>
            <a:ext cx="2256757" cy="154966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908" y="364131"/>
            <a:ext cx="3834700" cy="780550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80" y="1913800"/>
            <a:ext cx="2256757" cy="625583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527" y="6401912"/>
            <a:ext cx="4115753" cy="75578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527" y="817175"/>
            <a:ext cx="4115753" cy="548735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527" y="7157693"/>
            <a:ext cx="4115753" cy="107333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80" y="366247"/>
            <a:ext cx="6173629" cy="152426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80" y="2133971"/>
            <a:ext cx="6173629" cy="603566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79" y="8476606"/>
            <a:ext cx="1600571" cy="4869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/10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693" y="8476606"/>
            <a:ext cx="2172203" cy="4869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6038" y="8476606"/>
            <a:ext cx="1600571" cy="4869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" name="直接箭头连接符 2"/>
          <p:cNvCxnSpPr/>
          <p:nvPr/>
        </p:nvCxnSpPr>
        <p:spPr>
          <a:xfrm>
            <a:off x="3267410" y="1907866"/>
            <a:ext cx="0" cy="21602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/>
          <p:cNvSpPr txBox="1"/>
          <p:nvPr/>
        </p:nvSpPr>
        <p:spPr>
          <a:xfrm>
            <a:off x="2580199" y="1487447"/>
            <a:ext cx="1473917" cy="369332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HG/HF 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662318" y="2180822"/>
            <a:ext cx="1252602" cy="369332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err="1" smtClean="0">
                <a:latin typeface="Times New Roman" pitchFamily="18" charset="0"/>
                <a:cs typeface="Times New Roman" pitchFamily="18" charset="0"/>
              </a:rPr>
              <a:t>Salusin</a:t>
            </a:r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-β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373378" y="5139566"/>
            <a:ext cx="3749634" cy="369332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Diabetic endothelial </a:t>
            </a:r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dysfunction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8" name="直接连接符 17"/>
          <p:cNvCxnSpPr/>
          <p:nvPr/>
        </p:nvCxnSpPr>
        <p:spPr>
          <a:xfrm>
            <a:off x="1260048" y="5034882"/>
            <a:ext cx="394137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椭圆 18"/>
          <p:cNvSpPr/>
          <p:nvPr/>
        </p:nvSpPr>
        <p:spPr>
          <a:xfrm>
            <a:off x="2740740" y="2879985"/>
            <a:ext cx="1042992" cy="576064"/>
          </a:xfrm>
          <a:prstGeom prst="ellipse">
            <a:avLst/>
          </a:prstGeom>
          <a:solidFill>
            <a:schemeClr val="accent1">
              <a:lumMod val="20000"/>
              <a:lumOff val="80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TextBox 19"/>
          <p:cNvSpPr txBox="1"/>
          <p:nvPr/>
        </p:nvSpPr>
        <p:spPr>
          <a:xfrm>
            <a:off x="2857212" y="2980494"/>
            <a:ext cx="9571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PPAR-γ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矩形 20"/>
          <p:cNvSpPr/>
          <p:nvPr/>
        </p:nvSpPr>
        <p:spPr>
          <a:xfrm>
            <a:off x="2448213" y="3849676"/>
            <a:ext cx="1803682" cy="923330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xidative</a:t>
            </a:r>
          </a:p>
          <a:p>
            <a:pPr algn="ctr"/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itrative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tresses</a:t>
            </a:r>
          </a:p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flammatio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5" name="直接箭头连接符 24"/>
          <p:cNvCxnSpPr/>
          <p:nvPr/>
        </p:nvCxnSpPr>
        <p:spPr>
          <a:xfrm>
            <a:off x="3329211" y="4779526"/>
            <a:ext cx="0" cy="21602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接连接符 27"/>
          <p:cNvCxnSpPr/>
          <p:nvPr/>
        </p:nvCxnSpPr>
        <p:spPr>
          <a:xfrm>
            <a:off x="3267410" y="2573904"/>
            <a:ext cx="0" cy="25694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接连接符 28"/>
          <p:cNvCxnSpPr/>
          <p:nvPr/>
        </p:nvCxnSpPr>
        <p:spPr>
          <a:xfrm>
            <a:off x="3115856" y="2845360"/>
            <a:ext cx="2880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连接符 23"/>
          <p:cNvCxnSpPr/>
          <p:nvPr/>
        </p:nvCxnSpPr>
        <p:spPr>
          <a:xfrm>
            <a:off x="3264741" y="3528300"/>
            <a:ext cx="0" cy="25694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连接符 25"/>
          <p:cNvCxnSpPr/>
          <p:nvPr/>
        </p:nvCxnSpPr>
        <p:spPr>
          <a:xfrm>
            <a:off x="3113187" y="3799756"/>
            <a:ext cx="2880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839810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951</TotalTime>
  <Words>10</Words>
  <Application>Microsoft Office PowerPoint</Application>
  <PresentationFormat>自定义</PresentationFormat>
  <Paragraphs>7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hjlqb</dc:creator>
  <cp:lastModifiedBy>(null)</cp:lastModifiedBy>
  <cp:revision>410</cp:revision>
  <cp:lastPrinted>2017-10-06T09:05:38Z</cp:lastPrinted>
  <dcterms:created xsi:type="dcterms:W3CDTF">2017-01-05T12:19:51Z</dcterms:created>
  <dcterms:modified xsi:type="dcterms:W3CDTF">2017-10-10T14:50:18Z</dcterms:modified>
</cp:coreProperties>
</file>